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7640300" cy="10799763"/>
  <p:notesSz cx="9144000" cy="6858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6" roundtripDataSignature="AMtx7mgeEjA6ty9T/oz9L4+CiUhGeoqqX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95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471738" y="514350"/>
            <a:ext cx="4200525" cy="2571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8:notes"/>
          <p:cNvSpPr txBox="1">
            <a:spLocks noGrp="1"/>
          </p:cNvSpPr>
          <p:nvPr>
            <p:ph type="body" idx="1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76" name="Google Shape;76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71738" y="514350"/>
            <a:ext cx="4200525" cy="257175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2"/>
          <p:cNvSpPr txBox="1">
            <a:spLocks noGrp="1"/>
          </p:cNvSpPr>
          <p:nvPr>
            <p:ph type="title"/>
          </p:nvPr>
        </p:nvSpPr>
        <p:spPr>
          <a:xfrm>
            <a:off x="1212772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body" idx="1"/>
          </p:nvPr>
        </p:nvSpPr>
        <p:spPr>
          <a:xfrm>
            <a:off x="1212772" y="2874937"/>
            <a:ext cx="15214759" cy="6852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12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2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1"/>
          <p:cNvSpPr txBox="1">
            <a:spLocks noGrp="1"/>
          </p:cNvSpPr>
          <p:nvPr>
            <p:ph type="title"/>
          </p:nvPr>
        </p:nvSpPr>
        <p:spPr>
          <a:xfrm rot="5400000">
            <a:off x="9949535" y="3249293"/>
            <a:ext cx="9152300" cy="38036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body" idx="1"/>
          </p:nvPr>
        </p:nvSpPr>
        <p:spPr>
          <a:xfrm rot="5400000">
            <a:off x="2231905" y="-444144"/>
            <a:ext cx="9152300" cy="1119056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21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21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13"/>
          <p:cNvSpPr txBox="1">
            <a:spLocks noGrp="1"/>
          </p:cNvSpPr>
          <p:nvPr>
            <p:ph type="title"/>
          </p:nvPr>
        </p:nvSpPr>
        <p:spPr>
          <a:xfrm>
            <a:off x="1203586" y="2692445"/>
            <a:ext cx="15214759" cy="44924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9449"/>
              <a:buFont typeface="Calibri"/>
              <a:buNone/>
              <a:defRPr sz="623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13"/>
          <p:cNvSpPr txBox="1">
            <a:spLocks noGrp="1"/>
          </p:cNvSpPr>
          <p:nvPr>
            <p:ph type="body" idx="1"/>
          </p:nvPr>
        </p:nvSpPr>
        <p:spPr>
          <a:xfrm>
            <a:off x="1203586" y="7227344"/>
            <a:ext cx="15214759" cy="23624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2492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3150"/>
              <a:buNone/>
              <a:defRPr sz="2077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835"/>
              <a:buNone/>
              <a:defRPr sz="1869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rgbClr val="888888"/>
              </a:buClr>
              <a:buSzPts val="2520"/>
              <a:buNone/>
              <a:defRPr sz="1661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0" name="Google Shape;20;p13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13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13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14"/>
          <p:cNvSpPr txBox="1">
            <a:spLocks noGrp="1"/>
          </p:cNvSpPr>
          <p:nvPr>
            <p:ph type="title"/>
          </p:nvPr>
        </p:nvSpPr>
        <p:spPr>
          <a:xfrm>
            <a:off x="1212772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body" idx="1"/>
          </p:nvPr>
        </p:nvSpPr>
        <p:spPr>
          <a:xfrm>
            <a:off x="1212771" y="2874937"/>
            <a:ext cx="7497128" cy="6852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body" idx="2"/>
          </p:nvPr>
        </p:nvSpPr>
        <p:spPr>
          <a:xfrm>
            <a:off x="8930404" y="2874937"/>
            <a:ext cx="7497128" cy="6852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7" name="Google Shape;27;p14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4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4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15"/>
          <p:cNvSpPr txBox="1">
            <a:spLocks noGrp="1"/>
          </p:cNvSpPr>
          <p:nvPr>
            <p:ph type="title"/>
          </p:nvPr>
        </p:nvSpPr>
        <p:spPr>
          <a:xfrm>
            <a:off x="1215068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body" idx="1"/>
          </p:nvPr>
        </p:nvSpPr>
        <p:spPr>
          <a:xfrm>
            <a:off x="1215070" y="2647444"/>
            <a:ext cx="7462673" cy="12974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2492" b="1"/>
            </a:lvl1pPr>
            <a:lvl2pPr marL="914400" lvl="1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None/>
              <a:defRPr sz="2077" b="1"/>
            </a:lvl2pPr>
            <a:lvl3pPr marL="1371600" lvl="2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835"/>
              <a:buNone/>
              <a:defRPr sz="1869" b="1"/>
            </a:lvl3pPr>
            <a:lvl4pPr marL="1828800" lvl="3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4pPr>
            <a:lvl5pPr marL="2286000" lvl="4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5pPr>
            <a:lvl6pPr marL="2743200" lvl="5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6pPr>
            <a:lvl7pPr marL="3200400" lvl="6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7pPr>
            <a:lvl8pPr marL="3657600" lvl="7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8pPr>
            <a:lvl9pPr marL="4114800" lvl="8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9pPr>
          </a:lstStyle>
          <a:p>
            <a:endParaRPr/>
          </a:p>
        </p:txBody>
      </p:sp>
      <p:sp>
        <p:nvSpPr>
          <p:cNvPr id="33" name="Google Shape;33;p15"/>
          <p:cNvSpPr txBox="1">
            <a:spLocks noGrp="1"/>
          </p:cNvSpPr>
          <p:nvPr>
            <p:ph type="body" idx="2"/>
          </p:nvPr>
        </p:nvSpPr>
        <p:spPr>
          <a:xfrm>
            <a:off x="1215070" y="3944914"/>
            <a:ext cx="7462673" cy="580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4" name="Google Shape;34;p15"/>
          <p:cNvSpPr txBox="1">
            <a:spLocks noGrp="1"/>
          </p:cNvSpPr>
          <p:nvPr>
            <p:ph type="body" idx="3"/>
          </p:nvPr>
        </p:nvSpPr>
        <p:spPr>
          <a:xfrm>
            <a:off x="8930404" y="2647444"/>
            <a:ext cx="7499425" cy="129747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3780"/>
              <a:buNone/>
              <a:defRPr sz="2492" b="1"/>
            </a:lvl1pPr>
            <a:lvl2pPr marL="914400" lvl="1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None/>
              <a:defRPr sz="2077" b="1"/>
            </a:lvl2pPr>
            <a:lvl3pPr marL="1371600" lvl="2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835"/>
              <a:buNone/>
              <a:defRPr sz="1869" b="1"/>
            </a:lvl3pPr>
            <a:lvl4pPr marL="1828800" lvl="3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4pPr>
            <a:lvl5pPr marL="2286000" lvl="4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5pPr>
            <a:lvl6pPr marL="2743200" lvl="5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6pPr>
            <a:lvl7pPr marL="3200400" lvl="6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7pPr>
            <a:lvl8pPr marL="3657600" lvl="7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8pPr>
            <a:lvl9pPr marL="4114800" lvl="8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 b="1"/>
            </a:lvl9pPr>
          </a:lstStyle>
          <a:p>
            <a:endParaRPr/>
          </a:p>
        </p:txBody>
      </p:sp>
      <p:sp>
        <p:nvSpPr>
          <p:cNvPr id="35" name="Google Shape;35;p15"/>
          <p:cNvSpPr txBox="1">
            <a:spLocks noGrp="1"/>
          </p:cNvSpPr>
          <p:nvPr>
            <p:ph type="body" idx="4"/>
          </p:nvPr>
        </p:nvSpPr>
        <p:spPr>
          <a:xfrm>
            <a:off x="8930404" y="3944914"/>
            <a:ext cx="7499425" cy="580237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5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15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5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16"/>
          <p:cNvSpPr txBox="1">
            <a:spLocks noGrp="1"/>
          </p:cNvSpPr>
          <p:nvPr>
            <p:ph type="title"/>
          </p:nvPr>
        </p:nvSpPr>
        <p:spPr>
          <a:xfrm>
            <a:off x="1212772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6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6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6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7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8"/>
          <p:cNvSpPr txBox="1">
            <a:spLocks noGrp="1"/>
          </p:cNvSpPr>
          <p:nvPr>
            <p:ph type="title"/>
          </p:nvPr>
        </p:nvSpPr>
        <p:spPr>
          <a:xfrm>
            <a:off x="1215070" y="719985"/>
            <a:ext cx="5689456" cy="25199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39"/>
              <a:buFont typeface="Calibri"/>
              <a:buNone/>
              <a:defRPr sz="332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8"/>
          <p:cNvSpPr txBox="1">
            <a:spLocks noGrp="1"/>
          </p:cNvSpPr>
          <p:nvPr>
            <p:ph type="body" idx="1"/>
          </p:nvPr>
        </p:nvSpPr>
        <p:spPr>
          <a:xfrm>
            <a:off x="7499425" y="1554969"/>
            <a:ext cx="8930403" cy="767483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548576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5039"/>
              <a:buChar char="•"/>
              <a:defRPr sz="3323"/>
            </a:lvl1pPr>
            <a:lvl2pPr marL="914400" lvl="1" indent="-508571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4409"/>
              <a:buChar char="•"/>
              <a:defRPr sz="2907"/>
            </a:lvl2pPr>
            <a:lvl3pPr marL="1371600" lvl="2" indent="-46863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780"/>
              <a:buChar char="•"/>
              <a:defRPr sz="2492"/>
            </a:lvl3pPr>
            <a:lvl4pPr marL="1828800" lvl="3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4pPr>
            <a:lvl5pPr marL="2286000" lvl="4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5pPr>
            <a:lvl6pPr marL="2743200" lvl="5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6pPr>
            <a:lvl7pPr marL="3200400" lvl="6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7pPr>
            <a:lvl8pPr marL="3657600" lvl="7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8pPr>
            <a:lvl9pPr marL="4114800" lvl="8" indent="-428625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3150"/>
              <a:buChar char="•"/>
              <a:defRPr sz="2077"/>
            </a:lvl9pPr>
          </a:lstStyle>
          <a:p>
            <a:endParaRPr/>
          </a:p>
        </p:txBody>
      </p:sp>
      <p:sp>
        <p:nvSpPr>
          <p:cNvPr id="51" name="Google Shape;51;p18"/>
          <p:cNvSpPr txBox="1">
            <a:spLocks noGrp="1"/>
          </p:cNvSpPr>
          <p:nvPr>
            <p:ph type="body" idx="2"/>
          </p:nvPr>
        </p:nvSpPr>
        <p:spPr>
          <a:xfrm>
            <a:off x="1215070" y="3239931"/>
            <a:ext cx="5689456" cy="60023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/>
            </a:lvl1pPr>
            <a:lvl2pPr marL="914400" lvl="1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205"/>
              <a:buNone/>
              <a:defRPr sz="1454"/>
            </a:lvl2pPr>
            <a:lvl3pPr marL="1371600" lvl="2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246"/>
            </a:lvl3pPr>
            <a:lvl4pPr marL="1828800" lvl="3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4pPr>
            <a:lvl5pPr marL="2286000" lvl="4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5pPr>
            <a:lvl6pPr marL="2743200" lvl="5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6pPr>
            <a:lvl7pPr marL="3200400" lvl="6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7pPr>
            <a:lvl8pPr marL="3657600" lvl="7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8pPr>
            <a:lvl9pPr marL="4114800" lvl="8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8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9"/>
          <p:cNvSpPr txBox="1">
            <a:spLocks noGrp="1"/>
          </p:cNvSpPr>
          <p:nvPr>
            <p:ph type="title"/>
          </p:nvPr>
        </p:nvSpPr>
        <p:spPr>
          <a:xfrm>
            <a:off x="1215070" y="719985"/>
            <a:ext cx="5689456" cy="25199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5039"/>
              <a:buFont typeface="Calibri"/>
              <a:buNone/>
              <a:defRPr sz="3323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9"/>
          <p:cNvSpPr>
            <a:spLocks noGrp="1"/>
          </p:cNvSpPr>
          <p:nvPr>
            <p:ph type="pic" idx="2"/>
          </p:nvPr>
        </p:nvSpPr>
        <p:spPr>
          <a:xfrm>
            <a:off x="7499425" y="1554969"/>
            <a:ext cx="8930403" cy="7674831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9"/>
          <p:cNvSpPr txBox="1">
            <a:spLocks noGrp="1"/>
          </p:cNvSpPr>
          <p:nvPr>
            <p:ph type="body" idx="1"/>
          </p:nvPr>
        </p:nvSpPr>
        <p:spPr>
          <a:xfrm>
            <a:off x="1215070" y="3239931"/>
            <a:ext cx="5689456" cy="60023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2520"/>
              <a:buNone/>
              <a:defRPr sz="1661"/>
            </a:lvl1pPr>
            <a:lvl2pPr marL="914400" lvl="1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2205"/>
              <a:buNone/>
              <a:defRPr sz="1454"/>
            </a:lvl2pPr>
            <a:lvl3pPr marL="1371600" lvl="2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246"/>
            </a:lvl3pPr>
            <a:lvl4pPr marL="1828800" lvl="3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4pPr>
            <a:lvl5pPr marL="2286000" lvl="4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5pPr>
            <a:lvl6pPr marL="2743200" lvl="5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6pPr>
            <a:lvl7pPr marL="3200400" lvl="6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7pPr>
            <a:lvl8pPr marL="3657600" lvl="7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8pPr>
            <a:lvl9pPr marL="4114800" lvl="8" indent="-2286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039"/>
            </a:lvl9pPr>
          </a:lstStyle>
          <a:p>
            <a:endParaRPr/>
          </a:p>
        </p:txBody>
      </p:sp>
      <p:sp>
        <p:nvSpPr>
          <p:cNvPr id="59" name="Google Shape;59;p19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9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9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20"/>
          <p:cNvSpPr txBox="1">
            <a:spLocks noGrp="1"/>
          </p:cNvSpPr>
          <p:nvPr>
            <p:ph type="title"/>
          </p:nvPr>
        </p:nvSpPr>
        <p:spPr>
          <a:xfrm>
            <a:off x="1212772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0"/>
          <p:cNvSpPr txBox="1">
            <a:spLocks noGrp="1"/>
          </p:cNvSpPr>
          <p:nvPr>
            <p:ph type="body" idx="1"/>
          </p:nvPr>
        </p:nvSpPr>
        <p:spPr>
          <a:xfrm rot="5400000">
            <a:off x="5393976" y="-1306267"/>
            <a:ext cx="6852350" cy="152147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3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19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20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0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0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0"/>
          <p:cNvSpPr txBox="1">
            <a:spLocks noGrp="1"/>
          </p:cNvSpPr>
          <p:nvPr>
            <p:ph type="title"/>
          </p:nvPr>
        </p:nvSpPr>
        <p:spPr>
          <a:xfrm>
            <a:off x="1212772" y="574991"/>
            <a:ext cx="15214759" cy="20874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929"/>
              <a:buFont typeface="Calibri"/>
              <a:buNone/>
              <a:defRPr sz="692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10"/>
          <p:cNvSpPr txBox="1">
            <a:spLocks noGrp="1"/>
          </p:cNvSpPr>
          <p:nvPr>
            <p:ph type="body" idx="1"/>
          </p:nvPr>
        </p:nvSpPr>
        <p:spPr>
          <a:xfrm>
            <a:off x="1212772" y="2874937"/>
            <a:ext cx="15214759" cy="68523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508571" algn="l" rtl="0">
              <a:lnSpc>
                <a:spcPct val="90000"/>
              </a:lnSpc>
              <a:spcBef>
                <a:spcPts val="1575"/>
              </a:spcBef>
              <a:spcAft>
                <a:spcPts val="0"/>
              </a:spcAft>
              <a:buClr>
                <a:schemeClr val="dk1"/>
              </a:buClr>
              <a:buSzPts val="4409"/>
              <a:buFont typeface="Arial"/>
              <a:buChar char="•"/>
              <a:defRPr sz="440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68630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780"/>
              <a:buFont typeface="Arial"/>
              <a:buChar char="•"/>
              <a:defRPr sz="378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428625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3150"/>
              <a:buFont typeface="Arial"/>
              <a:buChar char="•"/>
              <a:defRPr sz="31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408622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835"/>
              <a:buFont typeface="Arial"/>
              <a:buChar char="•"/>
              <a:defRPr sz="283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0"/>
          <p:cNvSpPr txBox="1">
            <a:spLocks noGrp="1"/>
          </p:cNvSpPr>
          <p:nvPr>
            <p:ph type="dt" idx="10"/>
          </p:nvPr>
        </p:nvSpPr>
        <p:spPr>
          <a:xfrm>
            <a:off x="1212771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10"/>
          <p:cNvSpPr txBox="1">
            <a:spLocks noGrp="1"/>
          </p:cNvSpPr>
          <p:nvPr>
            <p:ph type="ftr" idx="11"/>
          </p:nvPr>
        </p:nvSpPr>
        <p:spPr>
          <a:xfrm>
            <a:off x="5843351" y="10009784"/>
            <a:ext cx="5953601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18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10"/>
          <p:cNvSpPr txBox="1">
            <a:spLocks noGrp="1"/>
          </p:cNvSpPr>
          <p:nvPr>
            <p:ph type="sldNum" idx="12"/>
          </p:nvPr>
        </p:nvSpPr>
        <p:spPr>
          <a:xfrm>
            <a:off x="12458462" y="10009784"/>
            <a:ext cx="3969068" cy="574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90"/>
              <a:buFont typeface="Arial"/>
              <a:buNone/>
              <a:defRPr sz="1246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/>
          <p:cNvGrpSpPr/>
          <p:nvPr/>
        </p:nvGrpSpPr>
        <p:grpSpPr>
          <a:xfrm>
            <a:off x="296614" y="2181853"/>
            <a:ext cx="16887159" cy="4583749"/>
            <a:chOff x="296614" y="294055"/>
            <a:chExt cx="16887159" cy="4583749"/>
          </a:xfrm>
        </p:grpSpPr>
        <p:sp>
          <p:nvSpPr>
            <p:cNvPr id="78" name="Google Shape;78;p8"/>
            <p:cNvSpPr txBox="1"/>
            <p:nvPr/>
          </p:nvSpPr>
          <p:spPr>
            <a:xfrm>
              <a:off x="2565615" y="294055"/>
              <a:ext cx="11646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fr-FR" sz="16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atient 9</a:t>
              </a:r>
              <a:endPara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79" name="Google Shape;79;p8"/>
            <p:cNvSpPr txBox="1"/>
            <p:nvPr/>
          </p:nvSpPr>
          <p:spPr>
            <a:xfrm>
              <a:off x="7643629" y="294055"/>
              <a:ext cx="11646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fr-FR" sz="16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atient 10</a:t>
              </a:r>
              <a:endPara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80" name="Google Shape;80;p8"/>
            <p:cNvGrpSpPr/>
            <p:nvPr/>
          </p:nvGrpSpPr>
          <p:grpSpPr>
            <a:xfrm>
              <a:off x="1250192" y="3556088"/>
              <a:ext cx="3370770" cy="1310203"/>
              <a:chOff x="1996647" y="5926900"/>
              <a:chExt cx="3522594" cy="1980056"/>
            </a:xfrm>
          </p:grpSpPr>
          <p:sp>
            <p:nvSpPr>
              <p:cNvPr id="81" name="Google Shape;81;p8"/>
              <p:cNvSpPr/>
              <p:nvPr/>
            </p:nvSpPr>
            <p:spPr>
              <a:xfrm>
                <a:off x="2017384" y="6145080"/>
                <a:ext cx="831272" cy="415637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D6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2" name="Google Shape;82;p8"/>
              <p:cNvSpPr/>
              <p:nvPr/>
            </p:nvSpPr>
            <p:spPr>
              <a:xfrm>
                <a:off x="2862450" y="6145080"/>
                <a:ext cx="1030586" cy="415637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PE 16 bp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3" name="Google Shape;83;p8"/>
              <p:cNvSpPr/>
              <p:nvPr/>
            </p:nvSpPr>
            <p:spPr>
              <a:xfrm>
                <a:off x="3915945" y="6145080"/>
                <a:ext cx="831272" cy="415637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A2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4" name="Google Shape;84;p8"/>
              <p:cNvSpPr txBox="1"/>
              <p:nvPr/>
            </p:nvSpPr>
            <p:spPr>
              <a:xfrm>
                <a:off x="4705649" y="6182532"/>
                <a:ext cx="813592" cy="4640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279 bp</a:t>
                </a:r>
                <a:endParaRPr sz="1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5" name="Google Shape;85;p8"/>
              <p:cNvSpPr/>
              <p:nvPr/>
            </p:nvSpPr>
            <p:spPr>
              <a:xfrm>
                <a:off x="2064642" y="7244181"/>
                <a:ext cx="831272" cy="415637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D6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6" name="Google Shape;86;p8"/>
              <p:cNvSpPr/>
              <p:nvPr/>
            </p:nvSpPr>
            <p:spPr>
              <a:xfrm>
                <a:off x="2882549" y="7244182"/>
                <a:ext cx="831272" cy="415637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A2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87" name="Google Shape;87;p8"/>
              <p:cNvSpPr txBox="1"/>
              <p:nvPr/>
            </p:nvSpPr>
            <p:spPr>
              <a:xfrm>
                <a:off x="3716428" y="7244182"/>
                <a:ext cx="880340" cy="4640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263 bp</a:t>
                </a:r>
                <a:endParaRPr sz="1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88" name="Google Shape;88;p8"/>
              <p:cNvCxnSpPr/>
              <p:nvPr/>
            </p:nvCxnSpPr>
            <p:spPr>
              <a:xfrm flipH="1">
                <a:off x="3322532" y="7904256"/>
                <a:ext cx="381600" cy="27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89" name="Google Shape;89;p8"/>
              <p:cNvCxnSpPr/>
              <p:nvPr/>
            </p:nvCxnSpPr>
            <p:spPr>
              <a:xfrm flipH="1">
                <a:off x="4324187" y="6743692"/>
                <a:ext cx="381463" cy="2648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90" name="Google Shape;90;p8"/>
              <p:cNvCxnSpPr/>
              <p:nvPr/>
            </p:nvCxnSpPr>
            <p:spPr>
              <a:xfrm rot="10800000" flipH="1">
                <a:off x="2043905" y="5926900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91" name="Google Shape;91;p8"/>
              <p:cNvCxnSpPr/>
              <p:nvPr/>
            </p:nvCxnSpPr>
            <p:spPr>
              <a:xfrm rot="10800000" flipH="1">
                <a:off x="1996647" y="7058505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</p:grpSp>
        <p:sp>
          <p:nvSpPr>
            <p:cNvPr id="92" name="Google Shape;92;p8"/>
            <p:cNvSpPr/>
            <p:nvPr/>
          </p:nvSpPr>
          <p:spPr>
            <a:xfrm>
              <a:off x="7180621" y="732127"/>
              <a:ext cx="25152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fr-FR" sz="1600" b="0" i="1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TYR</a:t>
              </a:r>
              <a:r>
                <a:rPr lang="fr-FR" sz="1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.1185-27463T&gt;G </a:t>
              </a:r>
              <a:endParaRPr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93" name="Google Shape;93;p8"/>
            <p:cNvGrpSpPr/>
            <p:nvPr/>
          </p:nvGrpSpPr>
          <p:grpSpPr>
            <a:xfrm>
              <a:off x="5908996" y="1699399"/>
              <a:ext cx="5329279" cy="1368543"/>
              <a:chOff x="9162681" y="2809699"/>
              <a:chExt cx="4659683" cy="1898908"/>
            </a:xfrm>
          </p:grpSpPr>
          <p:grpSp>
            <p:nvGrpSpPr>
              <p:cNvPr id="94" name="Google Shape;94;p8"/>
              <p:cNvGrpSpPr/>
              <p:nvPr/>
            </p:nvGrpSpPr>
            <p:grpSpPr>
              <a:xfrm>
                <a:off x="9162681" y="3192495"/>
                <a:ext cx="4659683" cy="1516112"/>
                <a:chOff x="7652268" y="2414803"/>
                <a:chExt cx="4682801" cy="1523633"/>
              </a:xfrm>
            </p:grpSpPr>
            <p:sp>
              <p:nvSpPr>
                <p:cNvPr id="95" name="Google Shape;95;p8"/>
                <p:cNvSpPr/>
                <p:nvPr/>
              </p:nvSpPr>
              <p:spPr>
                <a:xfrm>
                  <a:off x="8490858" y="3412837"/>
                  <a:ext cx="765110" cy="44787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96" name="Google Shape;96;p8"/>
                <p:cNvCxnSpPr/>
                <p:nvPr/>
              </p:nvCxnSpPr>
              <p:spPr>
                <a:xfrm>
                  <a:off x="9255968" y="3636772"/>
                  <a:ext cx="2313991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97" name="Google Shape;97;p8"/>
                <p:cNvSpPr/>
                <p:nvPr/>
              </p:nvSpPr>
              <p:spPr>
                <a:xfrm>
                  <a:off x="11569959" y="3431498"/>
                  <a:ext cx="765110" cy="44787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98" name="Google Shape;98;p8"/>
                <p:cNvSpPr/>
                <p:nvPr/>
              </p:nvSpPr>
              <p:spPr>
                <a:xfrm>
                  <a:off x="9983755" y="2636448"/>
                  <a:ext cx="1047431" cy="333252"/>
                </a:xfrm>
                <a:prstGeom prst="rect">
                  <a:avLst/>
                </a:prstGeom>
                <a:solidFill>
                  <a:srgbClr val="FF0000"/>
                </a:solidFill>
                <a:ln w="12700" cap="flat" cmpd="sng">
                  <a:solidFill>
                    <a:srgbClr val="FF0000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E242bp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99" name="Google Shape;99;p8"/>
                <p:cNvCxnSpPr/>
                <p:nvPr/>
              </p:nvCxnSpPr>
              <p:spPr>
                <a:xfrm>
                  <a:off x="9013372" y="2824037"/>
                  <a:ext cx="970383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00" name="Google Shape;100;p8"/>
                <p:cNvCxnSpPr/>
                <p:nvPr/>
              </p:nvCxnSpPr>
              <p:spPr>
                <a:xfrm>
                  <a:off x="11049847" y="2824037"/>
                  <a:ext cx="970383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101" name="Google Shape;101;p8"/>
                <p:cNvSpPr txBox="1"/>
                <p:nvPr/>
              </p:nvSpPr>
              <p:spPr>
                <a:xfrm>
                  <a:off x="8930259" y="2414803"/>
                  <a:ext cx="829202" cy="42816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345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sp>
              <p:nvSpPr>
                <p:cNvPr id="102" name="Google Shape;102;p8"/>
                <p:cNvSpPr txBox="1"/>
                <p:nvPr/>
              </p:nvSpPr>
              <p:spPr>
                <a:xfrm>
                  <a:off x="11061379" y="2445188"/>
                  <a:ext cx="853187" cy="42815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316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cxnSp>
              <p:nvCxnSpPr>
                <p:cNvPr id="103" name="Google Shape;103;p8"/>
                <p:cNvCxnSpPr/>
                <p:nvPr/>
              </p:nvCxnSpPr>
              <p:spPr>
                <a:xfrm>
                  <a:off x="8985377" y="2805373"/>
                  <a:ext cx="1488236" cy="831399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04" name="Google Shape;104;p8"/>
                <p:cNvCxnSpPr/>
                <p:nvPr/>
              </p:nvCxnSpPr>
              <p:spPr>
                <a:xfrm flipH="1">
                  <a:off x="10549263" y="2852895"/>
                  <a:ext cx="1403251" cy="783876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105" name="Google Shape;105;p8"/>
                <p:cNvSpPr txBox="1"/>
                <p:nvPr/>
              </p:nvSpPr>
              <p:spPr>
                <a:xfrm>
                  <a:off x="7813570" y="2661922"/>
                  <a:ext cx="1842900" cy="4284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Intron 3 </a:t>
                  </a:r>
                  <a:r>
                    <a:rPr lang="fr-FR" sz="1600" b="0" i="1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TYR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06" name="Google Shape;106;p8"/>
                <p:cNvSpPr txBox="1"/>
                <p:nvPr/>
              </p:nvSpPr>
              <p:spPr>
                <a:xfrm>
                  <a:off x="7652268" y="3510036"/>
                  <a:ext cx="1075500" cy="42840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pSPL3B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sp>
            <p:nvSpPr>
              <p:cNvPr id="107" name="Google Shape;107;p8"/>
              <p:cNvSpPr/>
              <p:nvPr/>
            </p:nvSpPr>
            <p:spPr>
              <a:xfrm>
                <a:off x="11230725" y="2809699"/>
                <a:ext cx="1682872" cy="42604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c.1185-27463T&gt;G 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108" name="Google Shape;108;p8"/>
              <p:cNvCxnSpPr/>
              <p:nvPr/>
            </p:nvCxnSpPr>
            <p:spPr>
              <a:xfrm>
                <a:off x="11339827" y="3131404"/>
                <a:ext cx="0" cy="460119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</p:grpSp>
        <p:grpSp>
          <p:nvGrpSpPr>
            <p:cNvPr id="109" name="Google Shape;109;p8"/>
            <p:cNvGrpSpPr/>
            <p:nvPr/>
          </p:nvGrpSpPr>
          <p:grpSpPr>
            <a:xfrm>
              <a:off x="296614" y="1261784"/>
              <a:ext cx="5252796" cy="1781034"/>
              <a:chOff x="1079119" y="2185998"/>
              <a:chExt cx="5254898" cy="1805773"/>
            </a:xfrm>
          </p:grpSpPr>
          <p:grpSp>
            <p:nvGrpSpPr>
              <p:cNvPr id="110" name="Google Shape;110;p8"/>
              <p:cNvGrpSpPr/>
              <p:nvPr/>
            </p:nvGrpSpPr>
            <p:grpSpPr>
              <a:xfrm>
                <a:off x="1079119" y="2591773"/>
                <a:ext cx="4882226" cy="1399998"/>
                <a:chOff x="7428623" y="2472425"/>
                <a:chExt cx="4906446" cy="1406943"/>
              </a:xfrm>
            </p:grpSpPr>
            <p:sp>
              <p:nvSpPr>
                <p:cNvPr id="111" name="Google Shape;111;p8"/>
                <p:cNvSpPr/>
                <p:nvPr/>
              </p:nvSpPr>
              <p:spPr>
                <a:xfrm>
                  <a:off x="8490858" y="3412837"/>
                  <a:ext cx="765110" cy="44787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112" name="Google Shape;112;p8"/>
                <p:cNvCxnSpPr/>
                <p:nvPr/>
              </p:nvCxnSpPr>
              <p:spPr>
                <a:xfrm>
                  <a:off x="9255968" y="3636772"/>
                  <a:ext cx="2313991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113" name="Google Shape;113;p8"/>
                <p:cNvSpPr/>
                <p:nvPr/>
              </p:nvSpPr>
              <p:spPr>
                <a:xfrm>
                  <a:off x="11569959" y="3431498"/>
                  <a:ext cx="765110" cy="44787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14" name="Google Shape;114;p8"/>
                <p:cNvSpPr/>
                <p:nvPr/>
              </p:nvSpPr>
              <p:spPr>
                <a:xfrm>
                  <a:off x="9983755" y="2637421"/>
                  <a:ext cx="858416" cy="335905"/>
                </a:xfrm>
                <a:prstGeom prst="rect">
                  <a:avLst/>
                </a:prstGeom>
                <a:solidFill>
                  <a:srgbClr val="FF0000"/>
                </a:solidFill>
                <a:ln w="12700" cap="flat" cmpd="sng">
                  <a:solidFill>
                    <a:srgbClr val="FF0000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E16bp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cxnSp>
              <p:nvCxnSpPr>
                <p:cNvPr id="115" name="Google Shape;115;p8"/>
                <p:cNvCxnSpPr/>
                <p:nvPr/>
              </p:nvCxnSpPr>
              <p:spPr>
                <a:xfrm>
                  <a:off x="9013372" y="2824037"/>
                  <a:ext cx="970383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16" name="Google Shape;116;p8"/>
                <p:cNvCxnSpPr/>
                <p:nvPr/>
              </p:nvCxnSpPr>
              <p:spPr>
                <a:xfrm>
                  <a:off x="10842171" y="2805373"/>
                  <a:ext cx="970383" cy="0"/>
                </a:xfrm>
                <a:prstGeom prst="straightConnector1">
                  <a:avLst/>
                </a:prstGeom>
                <a:noFill/>
                <a:ln w="28575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117" name="Google Shape;117;p8"/>
                <p:cNvSpPr txBox="1"/>
                <p:nvPr/>
              </p:nvSpPr>
              <p:spPr>
                <a:xfrm>
                  <a:off x="8948061" y="2472425"/>
                  <a:ext cx="989042" cy="3128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302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sp>
              <p:nvSpPr>
                <p:cNvPr id="118" name="Google Shape;118;p8"/>
                <p:cNvSpPr txBox="1"/>
                <p:nvPr/>
              </p:nvSpPr>
              <p:spPr>
                <a:xfrm>
                  <a:off x="11027098" y="2478895"/>
                  <a:ext cx="989042" cy="3128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299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  <p:cxnSp>
              <p:nvCxnSpPr>
                <p:cNvPr id="119" name="Google Shape;119;p8"/>
                <p:cNvCxnSpPr/>
                <p:nvPr/>
              </p:nvCxnSpPr>
              <p:spPr>
                <a:xfrm>
                  <a:off x="8985377" y="2805373"/>
                  <a:ext cx="1488236" cy="831399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cxnSp>
              <p:nvCxnSpPr>
                <p:cNvPr id="120" name="Google Shape;120;p8"/>
                <p:cNvCxnSpPr/>
                <p:nvPr/>
              </p:nvCxnSpPr>
              <p:spPr>
                <a:xfrm flipH="1">
                  <a:off x="10549263" y="2804401"/>
                  <a:ext cx="1244632" cy="832371"/>
                </a:xfrm>
                <a:prstGeom prst="straightConnector1">
                  <a:avLst/>
                </a:prstGeom>
                <a:noFill/>
                <a:ln w="19050" cap="flat" cmpd="sng">
                  <a:solidFill>
                    <a:schemeClr val="dk1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</p:cxnSp>
            <p:sp>
              <p:nvSpPr>
                <p:cNvPr id="121" name="Google Shape;121;p8"/>
                <p:cNvSpPr txBox="1"/>
                <p:nvPr/>
              </p:nvSpPr>
              <p:spPr>
                <a:xfrm>
                  <a:off x="7428623" y="2663695"/>
                  <a:ext cx="1842796" cy="3128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Intron 19 </a:t>
                  </a:r>
                  <a:r>
                    <a:rPr lang="fr-FR" sz="1600" b="0" i="1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OCA2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22" name="Google Shape;122;p8"/>
                <p:cNvSpPr txBox="1"/>
                <p:nvPr/>
              </p:nvSpPr>
              <p:spPr>
                <a:xfrm>
                  <a:off x="7652269" y="3510036"/>
                  <a:ext cx="1075355" cy="31288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pSPL3B</a:t>
                  </a:r>
                  <a:endParaRPr sz="1600" b="0" i="0" u="none" strike="noStrike" cap="none">
                    <a:solidFill>
                      <a:srgbClr val="000000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cxnSp>
            <p:nvCxnSpPr>
              <p:cNvPr id="123" name="Google Shape;123;p8"/>
              <p:cNvCxnSpPr/>
              <p:nvPr/>
            </p:nvCxnSpPr>
            <p:spPr>
              <a:xfrm>
                <a:off x="4563687" y="2461989"/>
                <a:ext cx="0" cy="460119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24" name="Google Shape;124;p8"/>
              <p:cNvSpPr/>
              <p:nvPr/>
            </p:nvSpPr>
            <p:spPr>
              <a:xfrm>
                <a:off x="4475815" y="2185998"/>
                <a:ext cx="1858202" cy="31133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.2080-20342A&gt;G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sp>
          <p:nvSpPr>
            <p:cNvPr id="125" name="Google Shape;125;p8"/>
            <p:cNvSpPr/>
            <p:nvPr/>
          </p:nvSpPr>
          <p:spPr>
            <a:xfrm>
              <a:off x="1957650" y="660889"/>
              <a:ext cx="24831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r>
                <a:rPr lang="fr-FR" sz="1600" b="0" i="1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OCA2</a:t>
              </a:r>
              <a:r>
                <a:rPr lang="fr-FR" sz="1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.2080-20342A&gt;G</a:t>
              </a:r>
              <a:endParaRPr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4" name="Google Shape;144;p8"/>
            <p:cNvSpPr txBox="1"/>
            <p:nvPr/>
          </p:nvSpPr>
          <p:spPr>
            <a:xfrm>
              <a:off x="13485951" y="311227"/>
              <a:ext cx="11919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fr-FR" sz="1600" b="1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atient 11</a:t>
              </a:r>
              <a:endParaRPr sz="16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5" name="Google Shape;145;p8"/>
            <p:cNvSpPr/>
            <p:nvPr/>
          </p:nvSpPr>
          <p:spPr>
            <a:xfrm>
              <a:off x="13078577" y="703125"/>
              <a:ext cx="2419500" cy="3072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60275" tIns="30125" rIns="60275" bIns="30125" anchor="t" anchorCtr="0">
              <a:sp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600"/>
                <a:buFont typeface="Arial"/>
                <a:buNone/>
              </a:pPr>
              <a:r>
                <a:rPr lang="fr-FR" sz="1600" b="0" i="1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OCA2</a:t>
              </a:r>
              <a:r>
                <a:rPr lang="fr-FR" sz="1600" b="0" i="0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c.1951+605G&gt;T</a:t>
              </a:r>
              <a:endParaRPr sz="16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grpSp>
          <p:nvGrpSpPr>
            <p:cNvPr id="146" name="Google Shape;146;p8"/>
            <p:cNvGrpSpPr/>
            <p:nvPr/>
          </p:nvGrpSpPr>
          <p:grpSpPr>
            <a:xfrm>
              <a:off x="11888857" y="1612721"/>
              <a:ext cx="5294916" cy="1802797"/>
              <a:chOff x="1221030" y="3702964"/>
              <a:chExt cx="4726338" cy="2283178"/>
            </a:xfrm>
          </p:grpSpPr>
          <p:sp>
            <p:nvSpPr>
              <p:cNvPr id="147" name="Google Shape;147;p8"/>
              <p:cNvSpPr/>
              <p:nvPr/>
            </p:nvSpPr>
            <p:spPr>
              <a:xfrm>
                <a:off x="2122134" y="5050323"/>
                <a:ext cx="761333" cy="445659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D6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148" name="Google Shape;148;p8"/>
              <p:cNvCxnSpPr/>
              <p:nvPr/>
            </p:nvCxnSpPr>
            <p:spPr>
              <a:xfrm>
                <a:off x="2883467" y="5273153"/>
                <a:ext cx="2302568" cy="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49" name="Google Shape;149;p8"/>
              <p:cNvSpPr/>
              <p:nvPr/>
            </p:nvSpPr>
            <p:spPr>
              <a:xfrm>
                <a:off x="5186035" y="5068892"/>
                <a:ext cx="761333" cy="445659"/>
              </a:xfrm>
              <a:prstGeom prst="rect">
                <a:avLst/>
              </a:prstGeom>
              <a:solidFill>
                <a:schemeClr val="accent1"/>
              </a:solidFill>
              <a:ln w="12700" cap="flat" cmpd="sng">
                <a:solidFill>
                  <a:srgbClr val="42719B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SA2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150" name="Google Shape;150;p8"/>
              <p:cNvSpPr/>
              <p:nvPr/>
            </p:nvSpPr>
            <p:spPr>
              <a:xfrm>
                <a:off x="3607662" y="4277766"/>
                <a:ext cx="1042260" cy="331607"/>
              </a:xfrm>
              <a:prstGeom prst="rect">
                <a:avLst/>
              </a:prstGeom>
              <a:solidFill>
                <a:srgbClr val="FF0000"/>
              </a:solidFill>
              <a:ln w="12700" cap="flat" cmpd="sng">
                <a:solidFill>
                  <a:srgbClr val="FF0000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  <p:txBody>
              <a:bodyPr spcFirstLastPara="1" wrap="square" lIns="60275" tIns="30125" rIns="60275" bIns="30125" anchor="ctr" anchorCtr="0">
                <a:noAutofit/>
              </a:bodyPr>
              <a:lstStyle/>
              <a:p>
                <a:pPr marL="0" marR="0" lvl="0" indent="0" algn="ctr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rPr>
                  <a:t>PE 149 bp</a:t>
                </a:r>
                <a:endParaRPr sz="1600" b="0" i="0" u="none" strike="noStrike" cap="none">
                  <a:solidFill>
                    <a:schemeClr val="lt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151" name="Google Shape;151;p8"/>
              <p:cNvCxnSpPr/>
              <p:nvPr/>
            </p:nvCxnSpPr>
            <p:spPr>
              <a:xfrm>
                <a:off x="2642069" y="4464429"/>
                <a:ext cx="965593" cy="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52" name="Google Shape;152;p8"/>
              <p:cNvCxnSpPr/>
              <p:nvPr/>
            </p:nvCxnSpPr>
            <p:spPr>
              <a:xfrm>
                <a:off x="4668491" y="4464429"/>
                <a:ext cx="965593" cy="0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3" name="Google Shape;153;p8"/>
              <p:cNvSpPr txBox="1"/>
              <p:nvPr/>
            </p:nvSpPr>
            <p:spPr>
              <a:xfrm>
                <a:off x="2577076" y="4132124"/>
                <a:ext cx="984300" cy="839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330 bp</a:t>
                </a:r>
                <a:endParaRPr sz="1600" b="0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154" name="Google Shape;154;p8"/>
              <p:cNvSpPr txBox="1"/>
              <p:nvPr/>
            </p:nvSpPr>
            <p:spPr>
              <a:xfrm>
                <a:off x="4649923" y="4133850"/>
                <a:ext cx="984300" cy="839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306 bp</a:t>
                </a:r>
                <a:endParaRPr sz="1600" b="0" i="0" u="none" strike="noStrike" cap="non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cxnSp>
            <p:nvCxnSpPr>
              <p:cNvPr id="155" name="Google Shape;155;p8"/>
              <p:cNvCxnSpPr/>
              <p:nvPr/>
            </p:nvCxnSpPr>
            <p:spPr>
              <a:xfrm>
                <a:off x="2614212" y="4445858"/>
                <a:ext cx="1480889" cy="827295"/>
              </a:xfrm>
              <a:prstGeom prst="straightConnector1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cxnSp>
            <p:nvCxnSpPr>
              <p:cNvPr id="156" name="Google Shape;156;p8"/>
              <p:cNvCxnSpPr/>
              <p:nvPr/>
            </p:nvCxnSpPr>
            <p:spPr>
              <a:xfrm flipH="1">
                <a:off x="4170378" y="4493145"/>
                <a:ext cx="1396324" cy="780007"/>
              </a:xfrm>
              <a:prstGeom prst="straightConnector1">
                <a:avLst/>
              </a:prstGeom>
              <a:noFill/>
              <a:ln w="19050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57" name="Google Shape;157;p8"/>
              <p:cNvSpPr txBox="1"/>
              <p:nvPr/>
            </p:nvSpPr>
            <p:spPr>
              <a:xfrm>
                <a:off x="1221030" y="4303115"/>
                <a:ext cx="1833600" cy="839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Intron 18  </a:t>
                </a:r>
                <a:r>
                  <a:rPr lang="fr-FR" sz="1600" b="0" i="1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OCA2</a:t>
                </a:r>
                <a:endParaRPr sz="1600" b="0" i="1" u="none" strike="noStrike" cap="none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sp>
            <p:nvSpPr>
              <p:cNvPr id="158" name="Google Shape;158;p8"/>
              <p:cNvSpPr txBox="1"/>
              <p:nvPr/>
            </p:nvSpPr>
            <p:spPr>
              <a:xfrm>
                <a:off x="1287684" y="5147042"/>
                <a:ext cx="1070100" cy="83910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pSPL3B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  <p:cxnSp>
            <p:nvCxnSpPr>
              <p:cNvPr id="159" name="Google Shape;159;p8"/>
              <p:cNvCxnSpPr/>
              <p:nvPr/>
            </p:nvCxnSpPr>
            <p:spPr>
              <a:xfrm>
                <a:off x="3464827" y="3996125"/>
                <a:ext cx="0" cy="460119"/>
              </a:xfrm>
              <a:prstGeom prst="straightConnector1">
                <a:avLst/>
              </a:prstGeom>
              <a:noFill/>
              <a:ln w="28575" cap="flat" cmpd="sng">
                <a:solidFill>
                  <a:schemeClr val="dk1"/>
                </a:solidFill>
                <a:prstDash val="solid"/>
                <a:miter lim="800000"/>
                <a:headEnd type="none" w="sm" len="sm"/>
                <a:tailEnd type="none" w="sm" len="sm"/>
              </a:ln>
            </p:spPr>
          </p:cxnSp>
          <p:sp>
            <p:nvSpPr>
              <p:cNvPr id="160" name="Google Shape;160;p8"/>
              <p:cNvSpPr/>
              <p:nvPr/>
            </p:nvSpPr>
            <p:spPr>
              <a:xfrm>
                <a:off x="3354657" y="3702964"/>
                <a:ext cx="1562765" cy="38890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60275" tIns="30125" rIns="60275" bIns="30125" anchor="t" anchorCtr="0">
                <a:spAutoFit/>
              </a:bodyPr>
              <a:lstStyle/>
              <a:p>
                <a:pPr marL="0" marR="0" lvl="0" indent="0" algn="l" rtl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Pts val="1600"/>
                  <a:buFont typeface="Arial"/>
                  <a:buNone/>
                </a:pPr>
                <a:r>
                  <a:rPr lang="fr-FR" sz="1600" b="0" i="0" u="none" strike="noStrike" cap="none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c.1951+605G&gt;T</a:t>
                </a:r>
                <a:endParaRPr sz="1600" b="0" i="0" u="none" strike="noStrike" cap="none">
                  <a:solidFill>
                    <a:srgbClr val="000000"/>
                  </a:solidFill>
                  <a:latin typeface="Arial"/>
                  <a:ea typeface="Arial"/>
                  <a:cs typeface="Arial"/>
                  <a:sym typeface="Arial"/>
                </a:endParaRPr>
              </a:p>
            </p:txBody>
          </p:sp>
        </p:grpSp>
        <p:grpSp>
          <p:nvGrpSpPr>
            <p:cNvPr id="161" name="Google Shape;161;p8"/>
            <p:cNvGrpSpPr/>
            <p:nvPr/>
          </p:nvGrpSpPr>
          <p:grpSpPr>
            <a:xfrm>
              <a:off x="12552156" y="3583265"/>
              <a:ext cx="2419608" cy="1203472"/>
              <a:chOff x="1759678" y="7067195"/>
              <a:chExt cx="3669781" cy="1825286"/>
            </a:xfrm>
          </p:grpSpPr>
          <p:grpSp>
            <p:nvGrpSpPr>
              <p:cNvPr id="162" name="Google Shape;162;p8"/>
              <p:cNvGrpSpPr/>
              <p:nvPr/>
            </p:nvGrpSpPr>
            <p:grpSpPr>
              <a:xfrm>
                <a:off x="1759678" y="7271936"/>
                <a:ext cx="3669781" cy="415637"/>
                <a:chOff x="1882082" y="5112326"/>
                <a:chExt cx="3669781" cy="415637"/>
              </a:xfrm>
            </p:grpSpPr>
            <p:sp>
              <p:nvSpPr>
                <p:cNvPr id="163" name="Google Shape;163;p8"/>
                <p:cNvSpPr/>
                <p:nvPr/>
              </p:nvSpPr>
              <p:spPr>
                <a:xfrm>
                  <a:off x="1882082" y="5112326"/>
                  <a:ext cx="831272" cy="415637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055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64" name="Google Shape;164;p8"/>
                <p:cNvSpPr/>
                <p:nvPr/>
              </p:nvSpPr>
              <p:spPr>
                <a:xfrm>
                  <a:off x="2727148" y="5112326"/>
                  <a:ext cx="1172884" cy="415637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E 149 bp</a:t>
                  </a:r>
                  <a:endParaRPr sz="1055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65" name="Google Shape;165;p8"/>
                <p:cNvSpPr/>
                <p:nvPr/>
              </p:nvSpPr>
              <p:spPr>
                <a:xfrm>
                  <a:off x="3863771" y="5112326"/>
                  <a:ext cx="831272" cy="415637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055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66" name="Google Shape;166;p8"/>
                <p:cNvSpPr txBox="1"/>
                <p:nvPr/>
              </p:nvSpPr>
              <p:spPr>
                <a:xfrm>
                  <a:off x="4632693" y="5149778"/>
                  <a:ext cx="919170" cy="338532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 412 bp</a:t>
                  </a:r>
                  <a:endParaRPr sz="1055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grpSp>
            <p:nvGrpSpPr>
              <p:cNvPr id="167" name="Google Shape;167;p8"/>
              <p:cNvGrpSpPr/>
              <p:nvPr/>
            </p:nvGrpSpPr>
            <p:grpSpPr>
              <a:xfrm>
                <a:off x="1837077" y="8241708"/>
                <a:ext cx="2411174" cy="421657"/>
                <a:chOff x="2034482" y="6470071"/>
                <a:chExt cx="2411174" cy="421657"/>
              </a:xfrm>
            </p:grpSpPr>
            <p:sp>
              <p:nvSpPr>
                <p:cNvPr id="168" name="Google Shape;168;p8"/>
                <p:cNvSpPr/>
                <p:nvPr/>
              </p:nvSpPr>
              <p:spPr>
                <a:xfrm>
                  <a:off x="2034482" y="6470071"/>
                  <a:ext cx="831272" cy="415637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055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69" name="Google Shape;169;p8"/>
                <p:cNvSpPr/>
                <p:nvPr/>
              </p:nvSpPr>
              <p:spPr>
                <a:xfrm>
                  <a:off x="2852389" y="6470072"/>
                  <a:ext cx="831272" cy="415637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055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170" name="Google Shape;170;p8"/>
                <p:cNvSpPr txBox="1"/>
                <p:nvPr/>
              </p:nvSpPr>
              <p:spPr>
                <a:xfrm>
                  <a:off x="3614387" y="6553197"/>
                  <a:ext cx="831269" cy="338531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055"/>
                    <a:buFont typeface="Arial"/>
                    <a:buNone/>
                  </a:pPr>
                  <a:r>
                    <a:rPr lang="fr-FR" sz="1055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263 bp</a:t>
                  </a:r>
                  <a:endParaRPr sz="1055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cxnSp>
            <p:nvCxnSpPr>
              <p:cNvPr id="171" name="Google Shape;171;p8"/>
              <p:cNvCxnSpPr/>
              <p:nvPr/>
            </p:nvCxnSpPr>
            <p:spPr>
              <a:xfrm rot="10800000" flipH="1">
                <a:off x="1829616" y="7067195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172" name="Google Shape;172;p8"/>
              <p:cNvCxnSpPr/>
              <p:nvPr/>
            </p:nvCxnSpPr>
            <p:spPr>
              <a:xfrm flipH="1">
                <a:off x="3041682" y="8889781"/>
                <a:ext cx="381600" cy="27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173" name="Google Shape;173;p8"/>
              <p:cNvCxnSpPr/>
              <p:nvPr/>
            </p:nvCxnSpPr>
            <p:spPr>
              <a:xfrm flipH="1">
                <a:off x="4147061" y="7904925"/>
                <a:ext cx="381600" cy="27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174" name="Google Shape;174;p8"/>
              <p:cNvCxnSpPr/>
              <p:nvPr/>
            </p:nvCxnSpPr>
            <p:spPr>
              <a:xfrm rot="10800000" flipH="1">
                <a:off x="1844806" y="8017117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</p:grpSp>
        <p:grpSp>
          <p:nvGrpSpPr>
            <p:cNvPr id="200" name="Google Shape;200;p8"/>
            <p:cNvGrpSpPr/>
            <p:nvPr/>
          </p:nvGrpSpPr>
          <p:grpSpPr>
            <a:xfrm>
              <a:off x="6700792" y="3624511"/>
              <a:ext cx="4102622" cy="1253293"/>
              <a:chOff x="9429103" y="5887721"/>
              <a:chExt cx="3734409" cy="1799415"/>
            </a:xfrm>
          </p:grpSpPr>
          <p:grpSp>
            <p:nvGrpSpPr>
              <p:cNvPr id="201" name="Google Shape;201;p8"/>
              <p:cNvGrpSpPr/>
              <p:nvPr/>
            </p:nvGrpSpPr>
            <p:grpSpPr>
              <a:xfrm>
                <a:off x="9429103" y="6063099"/>
                <a:ext cx="3734409" cy="476369"/>
                <a:chOff x="1882082" y="5112326"/>
                <a:chExt cx="3734409" cy="476369"/>
              </a:xfrm>
            </p:grpSpPr>
            <p:sp>
              <p:nvSpPr>
                <p:cNvPr id="202" name="Google Shape;202;p8"/>
                <p:cNvSpPr/>
                <p:nvPr/>
              </p:nvSpPr>
              <p:spPr>
                <a:xfrm>
                  <a:off x="1882082" y="5112326"/>
                  <a:ext cx="831300" cy="41550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03" name="Google Shape;203;p8"/>
                <p:cNvSpPr/>
                <p:nvPr/>
              </p:nvSpPr>
              <p:spPr>
                <a:xfrm>
                  <a:off x="2727148" y="5112326"/>
                  <a:ext cx="1173000" cy="41550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PE 242 bp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04" name="Google Shape;204;p8"/>
                <p:cNvSpPr/>
                <p:nvPr/>
              </p:nvSpPr>
              <p:spPr>
                <a:xfrm>
                  <a:off x="3863771" y="5112326"/>
                  <a:ext cx="831300" cy="41550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05" name="Google Shape;205;p8"/>
                <p:cNvSpPr txBox="1"/>
                <p:nvPr/>
              </p:nvSpPr>
              <p:spPr>
                <a:xfrm>
                  <a:off x="4743440" y="5147820"/>
                  <a:ext cx="873051" cy="44087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505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grpSp>
            <p:nvGrpSpPr>
              <p:cNvPr id="206" name="Google Shape;206;p8"/>
              <p:cNvGrpSpPr/>
              <p:nvPr/>
            </p:nvGrpSpPr>
            <p:grpSpPr>
              <a:xfrm>
                <a:off x="9651037" y="7036363"/>
                <a:ext cx="2309985" cy="500442"/>
                <a:chOff x="2034482" y="6470071"/>
                <a:chExt cx="2309985" cy="500442"/>
              </a:xfrm>
            </p:grpSpPr>
            <p:sp>
              <p:nvSpPr>
                <p:cNvPr id="207" name="Google Shape;207;p8"/>
                <p:cNvSpPr/>
                <p:nvPr/>
              </p:nvSpPr>
              <p:spPr>
                <a:xfrm>
                  <a:off x="2034482" y="6470071"/>
                  <a:ext cx="831300" cy="41550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D6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08" name="Google Shape;208;p8"/>
                <p:cNvSpPr/>
                <p:nvPr/>
              </p:nvSpPr>
              <p:spPr>
                <a:xfrm>
                  <a:off x="2852389" y="6470072"/>
                  <a:ext cx="831300" cy="415500"/>
                </a:xfrm>
                <a:prstGeom prst="rect">
                  <a:avLst/>
                </a:prstGeom>
                <a:solidFill>
                  <a:schemeClr val="accent1"/>
                </a:solidFill>
                <a:ln w="12700" cap="flat" cmpd="sng">
                  <a:solidFill>
                    <a:srgbClr val="42719B"/>
                  </a:solidFill>
                  <a:prstDash val="solid"/>
                  <a:miter lim="800000"/>
                  <a:headEnd type="none" w="sm" len="sm"/>
                  <a:tailEnd type="none" w="sm" len="sm"/>
                </a:ln>
              </p:spPr>
              <p:txBody>
                <a:bodyPr spcFirstLastPara="1" wrap="square" lIns="60275" tIns="30125" rIns="60275" bIns="30125" anchor="ctr" anchorCtr="0">
                  <a:noAutofit/>
                </a:bodyPr>
                <a:lstStyle/>
                <a:p>
                  <a:pPr marL="0" marR="0" lvl="0" indent="0" algn="ctr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lt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SA2</a:t>
                  </a:r>
                  <a:endParaRPr sz="1600" b="0" i="0" u="none" strike="noStrike" cap="none">
                    <a:solidFill>
                      <a:schemeClr val="lt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  <p:sp>
              <p:nvSpPr>
                <p:cNvPr id="209" name="Google Shape;209;p8"/>
                <p:cNvSpPr txBox="1"/>
                <p:nvPr/>
              </p:nvSpPr>
              <p:spPr>
                <a:xfrm>
                  <a:off x="3660023" y="6529639"/>
                  <a:ext cx="684444" cy="44087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60275" tIns="30125" rIns="60275" bIns="30125" anchor="t" anchorCtr="0">
                  <a:spAutoFit/>
                </a:bodyPr>
                <a:lstStyle/>
                <a:p>
                  <a:pPr marL="0" marR="0" lvl="0" indent="0" algn="l" rtl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>
                      <a:srgbClr val="000000"/>
                    </a:buClr>
                    <a:buSzPts val="1600"/>
                    <a:buFont typeface="Arial"/>
                    <a:buNone/>
                  </a:pPr>
                  <a:r>
                    <a:rPr lang="fr-FR" sz="1600" b="0" i="0" u="none" strike="noStrike" cap="none">
                      <a:solidFill>
                        <a:schemeClr val="dk1"/>
                      </a:solidFill>
                      <a:latin typeface="Arial"/>
                      <a:ea typeface="Arial"/>
                      <a:cs typeface="Arial"/>
                      <a:sym typeface="Arial"/>
                    </a:rPr>
                    <a:t>263 bp</a:t>
                  </a:r>
                  <a:endParaRPr sz="1600" b="0" i="0" u="none" strike="noStrike" cap="none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endParaRPr>
                </a:p>
              </p:txBody>
            </p:sp>
          </p:grpSp>
          <p:cxnSp>
            <p:nvCxnSpPr>
              <p:cNvPr id="210" name="Google Shape;210;p8"/>
              <p:cNvCxnSpPr/>
              <p:nvPr/>
            </p:nvCxnSpPr>
            <p:spPr>
              <a:xfrm flipH="1">
                <a:off x="10855642" y="7684436"/>
                <a:ext cx="381600" cy="27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211" name="Google Shape;211;p8"/>
              <p:cNvCxnSpPr/>
              <p:nvPr/>
            </p:nvCxnSpPr>
            <p:spPr>
              <a:xfrm flipH="1">
                <a:off x="11961021" y="6699580"/>
                <a:ext cx="381600" cy="27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212" name="Google Shape;212;p8"/>
              <p:cNvCxnSpPr/>
              <p:nvPr/>
            </p:nvCxnSpPr>
            <p:spPr>
              <a:xfrm rot="10800000" flipH="1">
                <a:off x="9658766" y="6811772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  <p:cxnSp>
            <p:nvCxnSpPr>
              <p:cNvPr id="213" name="Google Shape;213;p8"/>
              <p:cNvCxnSpPr/>
              <p:nvPr/>
            </p:nvCxnSpPr>
            <p:spPr>
              <a:xfrm rot="10800000" flipH="1">
                <a:off x="9642672" y="5887721"/>
                <a:ext cx="436500" cy="1200"/>
              </a:xfrm>
              <a:prstGeom prst="straightConnector1">
                <a:avLst/>
              </a:prstGeom>
              <a:noFill/>
              <a:ln w="38100" cap="flat" cmpd="sng">
                <a:solidFill>
                  <a:schemeClr val="accent1"/>
                </a:solidFill>
                <a:prstDash val="solid"/>
                <a:miter lim="800000"/>
                <a:headEnd type="none" w="sm" len="sm"/>
                <a:tailEnd type="triangle" w="med" len="med"/>
              </a:ln>
            </p:spPr>
          </p:cxn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4</Words>
  <Application>Microsoft Office PowerPoint</Application>
  <PresentationFormat>Personnalisé</PresentationFormat>
  <Paragraphs>5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dibo Diallo</dc:creator>
  <cp:lastModifiedBy>ARVEILER Benoit</cp:lastModifiedBy>
  <cp:revision>3</cp:revision>
  <dcterms:created xsi:type="dcterms:W3CDTF">2024-04-06T13:46:04Z</dcterms:created>
  <dcterms:modified xsi:type="dcterms:W3CDTF">2024-07-22T21:43:55Z</dcterms:modified>
</cp:coreProperties>
</file>